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9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02" autoAdjust="0"/>
    <p:restoredTop sz="85612" autoAdjust="0"/>
  </p:normalViewPr>
  <p:slideViewPr>
    <p:cSldViewPr>
      <p:cViewPr>
        <p:scale>
          <a:sx n="100" d="100"/>
          <a:sy n="100" d="100"/>
        </p:scale>
        <p:origin x="-2064" y="214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257D7-D7BE-4475-912D-A861A539B70E}" type="datetimeFigureOut">
              <a:rPr lang="it-IT" smtClean="0"/>
              <a:t>27/11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671"/>
            <a:ext cx="2946400" cy="4969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671"/>
            <a:ext cx="2946400" cy="4969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067331-E300-493D-B25C-E95C2384BC2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9488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5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4DDC09-3A55-4B16-AD34-7AD3F499AB41}" type="datetimeFigureOut">
              <a:rPr lang="it-IT" smtClean="0"/>
              <a:t>27/11/201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8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5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1D5D10-F67F-430D-926A-A83F6D16763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871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1D5D10-F67F-430D-926A-A83F6D16763D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7209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9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7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7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3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Box 26"/>
          <p:cNvSpPr txBox="1">
            <a:spLocks noChangeArrowheads="1"/>
          </p:cNvSpPr>
          <p:nvPr/>
        </p:nvSpPr>
        <p:spPr bwMode="auto">
          <a:xfrm>
            <a:off x="1777317" y="36249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26"/>
          <p:cNvSpPr txBox="1">
            <a:spLocks noChangeArrowheads="1"/>
          </p:cNvSpPr>
          <p:nvPr/>
        </p:nvSpPr>
        <p:spPr bwMode="auto">
          <a:xfrm>
            <a:off x="3839700" y="362490"/>
            <a:ext cx="105244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1/2 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en-US" altLang="it-IT" sz="9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26"/>
          <p:cNvSpPr txBox="1">
            <a:spLocks noChangeArrowheads="1"/>
          </p:cNvSpPr>
          <p:nvPr/>
        </p:nvSpPr>
        <p:spPr bwMode="auto">
          <a:xfrm rot="16200000">
            <a:off x="536090" y="1623649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7°C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 Box 26"/>
          <p:cNvSpPr txBox="1">
            <a:spLocks noChangeArrowheads="1"/>
          </p:cNvSpPr>
          <p:nvPr/>
        </p:nvSpPr>
        <p:spPr bwMode="auto">
          <a:xfrm rot="16200000">
            <a:off x="420554" y="3713358"/>
            <a:ext cx="98831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old treatment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Connettore 1 55"/>
          <p:cNvCxnSpPr/>
          <p:nvPr/>
        </p:nvCxnSpPr>
        <p:spPr>
          <a:xfrm>
            <a:off x="1049390" y="2191401"/>
            <a:ext cx="324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5" name="Picture 11" descr="K:\## Molecular Oncology\Livio Trusolino\Tankyrase &amp; TNIK\Group\Tankyrase\1-Quaderni\Tankyrase - da settembre 2012\2015\REVISIONE_Cold Treatment\2-shTNKS 0 min_02_ProjMax001_ch00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6500" y="603962"/>
            <a:ext cx="2117725" cy="2160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K:\## Molecular Oncology\Livio Trusolino\Tankyrase &amp; TNIK\Group\Tankyrase\1-Quaderni\Tankyrase - da settembre 2012\2015\REVISIONE_Cold Treatment\1-scramble 0 min_03_ProjMax001_ch0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9400" y="603962"/>
            <a:ext cx="2117725" cy="2160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K:\## Molecular Oncology\Livio Trusolino\Tankyrase &amp; TNIK\Group\Tankyrase\1-Quaderni\Tankyrase - da settembre 2012\2015\REVISIONE_Cold Treatment\3-scramble 6 min_03_ProjMax001_ch00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9400" y="2882769"/>
            <a:ext cx="2117725" cy="2160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K:\## Molecular Oncology\Livio Trusolino\Tankyrase &amp; TNIK\Group\Tankyrase\1-Quaderni\Tankyrase - da settembre 2012\2015\REVISIONE_Cold Treatment\4-shTNKS 6 min_04_ProjMax001_ch0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6500" y="2882769"/>
            <a:ext cx="2117725" cy="2160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4239090" y="9567319"/>
            <a:ext cx="24497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4: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03676" y="5493060"/>
            <a:ext cx="5850650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: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NKS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lencing stabilizes the microtubule network</a:t>
            </a:r>
          </a:p>
          <a:p>
            <a:pPr algn="just"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focal images of 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microtubules in standard conditions (37°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r after cold exposure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549 cells were stably transduc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 shRNA (mock) or TNKS1/2-directed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rior to cold treatment for 6 min. Cells were then immediately fixed and stained with anti-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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tubulin antibody. Shown here are representative images of one experiment out of two performed. Scale bar, 7 </a:t>
            </a:r>
            <a:r>
              <a:rPr lang="en-US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Connettore 1 55"/>
          <p:cNvCxnSpPr/>
          <p:nvPr/>
        </p:nvCxnSpPr>
        <p:spPr>
          <a:xfrm>
            <a:off x="1211390" y="2641768"/>
            <a:ext cx="41148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09253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018</TotalTime>
  <Words>103</Words>
  <Application>Microsoft Office PowerPoint</Application>
  <PresentationFormat>A4 Paper (210x297 mm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Lupo</dc:creator>
  <cp:lastModifiedBy>ltrusolino</cp:lastModifiedBy>
  <cp:revision>532</cp:revision>
  <cp:lastPrinted>2014-11-07T12:40:06Z</cp:lastPrinted>
  <dcterms:created xsi:type="dcterms:W3CDTF">2006-08-16T00:00:00Z</dcterms:created>
  <dcterms:modified xsi:type="dcterms:W3CDTF">2015-11-27T18:24:44Z</dcterms:modified>
</cp:coreProperties>
</file>